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E4BDB-0663-4DE1-9C62-20776185FE6C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BCED7-1DD7-472E-BDDD-62EC9F014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9172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E4BDB-0663-4DE1-9C62-20776185FE6C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BCED7-1DD7-472E-BDDD-62EC9F014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2359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E4BDB-0663-4DE1-9C62-20776185FE6C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BCED7-1DD7-472E-BDDD-62EC9F014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3968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E4BDB-0663-4DE1-9C62-20776185FE6C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BCED7-1DD7-472E-BDDD-62EC9F014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0983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E4BDB-0663-4DE1-9C62-20776185FE6C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BCED7-1DD7-472E-BDDD-62EC9F014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9297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E4BDB-0663-4DE1-9C62-20776185FE6C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BCED7-1DD7-472E-BDDD-62EC9F014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0942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E4BDB-0663-4DE1-9C62-20776185FE6C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BCED7-1DD7-472E-BDDD-62EC9F014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3531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E4BDB-0663-4DE1-9C62-20776185FE6C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BCED7-1DD7-472E-BDDD-62EC9F014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4359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E4BDB-0663-4DE1-9C62-20776185FE6C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BCED7-1DD7-472E-BDDD-62EC9F014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8289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E4BDB-0663-4DE1-9C62-20776185FE6C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BCED7-1DD7-472E-BDDD-62EC9F014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8853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E4BDB-0663-4DE1-9C62-20776185FE6C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BCED7-1DD7-472E-BDDD-62EC9F014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6544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FE4BDB-0663-4DE1-9C62-20776185FE6C}" type="datetimeFigureOut">
              <a:rPr lang="de-DE" smtClean="0"/>
              <a:t>12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0BCED7-1DD7-472E-BDDD-62EC9F014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7211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1628800"/>
            <a:ext cx="6192688" cy="4704581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hteck 2">
            <a:extLst>
              <a:ext uri="{FF2B5EF4-FFF2-40B4-BE49-F238E27FC236}">
                <a16:creationId xmlns:a16="http://schemas.microsoft.com/office/drawing/2014/main" id="{60125ACC-71EE-4C92-BB32-C96A81BD2444}"/>
              </a:ext>
            </a:extLst>
          </p:cNvPr>
          <p:cNvSpPr/>
          <p:nvPr/>
        </p:nvSpPr>
        <p:spPr>
          <a:xfrm>
            <a:off x="395536" y="188640"/>
            <a:ext cx="6192688" cy="9668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materials: Figure 1: Summary of Conditional MR Use. Excerpt from the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ivaNova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LC MRI Labelling (MRI with the VNS Therapy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®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ystem; page 8; October 2019).</a:t>
            </a:r>
            <a:endParaRPr lang="de-D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647351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Office PowerPoint</Application>
  <PresentationFormat>Bildschirmpräsentatio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Larissa</vt:lpstr>
      <vt:lpstr>PowerPoint-Präsentation</vt:lpstr>
    </vt:vector>
  </TitlesOfParts>
  <Company>Universitätsklinikum Erla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rollmann, Regina</dc:creator>
  <cp:lastModifiedBy>Trollmann, Regina</cp:lastModifiedBy>
  <cp:revision>2</cp:revision>
  <dcterms:created xsi:type="dcterms:W3CDTF">2021-01-25T17:31:38Z</dcterms:created>
  <dcterms:modified xsi:type="dcterms:W3CDTF">2021-02-12T18:28:01Z</dcterms:modified>
</cp:coreProperties>
</file>